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5DC78-FE9D-4A1F-BEED-1A29AE5C0B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3BA1A-754C-4239-9DC5-BF787C6BDB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481C6C-9D92-4B58-A4EB-87471C4E6A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90543-2CF2-434A-A372-F32DE914D1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AD721-C266-4A4C-BAB5-2756C83D6D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E72C6-9649-4659-86B1-37B7303030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41BE1-279C-4603-9AA0-A2B7C9042E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4D5C3-EB9D-4919-8617-C401AC98D0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41242-9115-4B6E-B85A-C1ED465A2C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CB64A-5513-4336-A1BA-ED00D13318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18809-C727-4CC9-9665-BC4F79420E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CE907-3834-47BB-9E8F-1D88EBF53A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8044FF-29C1-4EC0-900D-07FAB223651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mparison of the growth rates in two experiments with a dynamic volatility basis set (VBS) mod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1863720"/>
            <a:ext cx="4800600" cy="31608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D:\PPT_Out\nature-logo.jpg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J Tröstl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et al. Natur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33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27–531 (2016) doi:10.1038/nature1827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18T09:41:06Z</dcterms:created>
  <dc:creator>ravikumar.n</dc:creator>
  <dc:description/>
  <dc:language>en-US</dc:language>
  <cp:lastModifiedBy>R.Vijitha</cp:lastModifiedBy>
  <dcterms:modified xsi:type="dcterms:W3CDTF">2016-05-18T09:42:41Z</dcterms:modified>
  <cp:revision>2</cp:revision>
  <dc:subject/>
  <dc:title>Comparison of the growth rates in two experiments with a dynamic volatility basis set (VBS) model</dc:title>
</cp:coreProperties>
</file>